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42" d="100"/>
          <a:sy n="142" d="100"/>
        </p:scale>
        <p:origin x="-696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215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717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780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267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403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06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132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35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429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341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672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57F0D-016F-794C-A3A9-A8143618F082}" type="datetimeFigureOut">
              <a:rPr lang="en-US" smtClean="0"/>
              <a:t>1/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1E81B6-1442-7A4C-A7CB-BD692174D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085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0484638"/>
              </p:ext>
            </p:extLst>
          </p:nvPr>
        </p:nvGraphicFramePr>
        <p:xfrm>
          <a:off x="108295" y="276985"/>
          <a:ext cx="8929861" cy="6358286"/>
        </p:xfrm>
        <a:graphic>
          <a:graphicData uri="http://schemas.openxmlformats.org/drawingml/2006/table">
            <a:tbl>
              <a:tblPr/>
              <a:tblGrid>
                <a:gridCol w="884817"/>
                <a:gridCol w="1061782"/>
                <a:gridCol w="1497387"/>
                <a:gridCol w="4029327"/>
                <a:gridCol w="1456548"/>
              </a:tblGrid>
              <a:tr h="151633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Helvetica"/>
                      </a:endParaRP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sng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Fold increase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sng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genbank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sng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genedescription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sng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genesymbol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1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20708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ecretory leukocyte peptidase inhibitor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LPI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7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6928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defensin, beta 4A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DEFB4A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48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F146796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olute carrier family 34 (sodium phosphate), member 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LC34A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4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105796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erum amyloid A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AA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36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3308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lipocalin 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LCN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6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2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15017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omplement component 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2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R54225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epithelial cell adhesion molecule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EPCAM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8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2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3235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ajor histocompatibility complex, class II, DR alpha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HLA-DRA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2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20698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hemokine (C-C motif) ligand 2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CL2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1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2079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erum amyloid A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AA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06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14666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eruloplasmin (ferroxidase)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P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0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3445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indoleamine 2,3-dioxygenase 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IDO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0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2086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albindin 1, 28kDa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ALB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0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Y00772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al, T-cell differentiation protein 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AL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9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K09240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urothelial cancer associated 1 (non-protein coding)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UCA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6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9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0532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ribonuclease, RNase A family, 1 (pancreatic)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RNASE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9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3301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epithelial cell adhesion molecule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EPCAM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8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8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1095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eptidase inhibitor 3, skin-derived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I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1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8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U3966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vanin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 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VNN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8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F41444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ucin 16, cell surface associated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UC16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7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61886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rogestagen-associated endometrial protein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AEP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7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K09304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erpin peptidase inhibitor member 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ERPINA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7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F065388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tetraspanin 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TSPAN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6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0363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atrix metallopeptidase 7 (matrilysin, uterine)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MP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6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13709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etastasis associated in colon cancer 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ACC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29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6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6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F151978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olute carrier family 6 (amino acid transporter), member 1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LC6A1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6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J0558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ucin 1, cell surface associated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UC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8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6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1199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erpin peptidase inhibitor member 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ERPINA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2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F027208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rominin 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ROM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3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8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F27214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olymeric immunoglobulin receptor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IGR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3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1170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transmembrane protease, serine 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TMPRSS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3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EU70949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adherin 1, type 1, E-cadherin (epithelial)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DH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3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0270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keratin 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KRT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3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F22842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hromosome 15 open reading frame 48 | microRNA 147b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15orf48|MIR147B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3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F20397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ets homologous factor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EHF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36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1230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DZK1 interacting protein 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DZK1IP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3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5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18726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Helvetica"/>
                      </a:endParaRP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D74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38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47677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defensin, beta 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DEFB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E9D9"/>
                    </a:solidFill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3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1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BC032722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tumor necrosis factor (ligand) superfamily, member 1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TNFSF1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6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40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49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EF15228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glucosaminyl (N-acetyl) transferase 3, mucin type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GCNT3</a:t>
                      </a:r>
                    </a:p>
                  </a:txBody>
                  <a:tcPr marL="7774" marR="7774" marT="77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96080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5</Words>
  <Application>Microsoft Macintosh PowerPoint</Application>
  <PresentationFormat>On-screen Show (4:3)</PresentationFormat>
  <Paragraphs>20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dia</dc:creator>
  <cp:lastModifiedBy>Nadia</cp:lastModifiedBy>
  <cp:revision>4</cp:revision>
  <dcterms:created xsi:type="dcterms:W3CDTF">2016-01-11T22:10:31Z</dcterms:created>
  <dcterms:modified xsi:type="dcterms:W3CDTF">2017-01-02T19:53:24Z</dcterms:modified>
</cp:coreProperties>
</file>